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594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5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88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426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403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93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1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590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91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39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91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913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664AB04-4FCB-FD9A-E026-8FF4F4AE08FB}"/>
              </a:ext>
            </a:extLst>
          </p:cNvPr>
          <p:cNvSpPr/>
          <p:nvPr/>
        </p:nvSpPr>
        <p:spPr>
          <a:xfrm>
            <a:off x="492219" y="327943"/>
            <a:ext cx="586067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Examples of  LC-MS spectra obtained following fragmentation of recombinant PAF and PAF/GNA proteins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A1B2235-A110-56A4-BAAB-D4E001DB439D}"/>
              </a:ext>
            </a:extLst>
          </p:cNvPr>
          <p:cNvGrpSpPr/>
          <p:nvPr/>
        </p:nvGrpSpPr>
        <p:grpSpPr>
          <a:xfrm>
            <a:off x="492219" y="1102122"/>
            <a:ext cx="4889496" cy="8454051"/>
            <a:chOff x="492219" y="1102122"/>
            <a:chExt cx="4889496" cy="8454051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823DB88-F059-9C95-1F73-300096FACA7C}"/>
                </a:ext>
              </a:extLst>
            </p:cNvPr>
            <p:cNvSpPr txBox="1"/>
            <p:nvPr/>
          </p:nvSpPr>
          <p:spPr>
            <a:xfrm>
              <a:off x="492219" y="1139044"/>
              <a:ext cx="6944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a. PAF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3CCD2D3-D712-15BB-240A-DB5EAD70EC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674" y="1102122"/>
              <a:ext cx="2800163" cy="186784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BD5DC73-88EA-B296-2D86-5156B7C82E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673" y="3264669"/>
              <a:ext cx="2800164" cy="186784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3A800B4-B5FC-144B-C347-FC033037EC1D}"/>
                </a:ext>
              </a:extLst>
            </p:cNvPr>
            <p:cNvSpPr txBox="1"/>
            <p:nvPr/>
          </p:nvSpPr>
          <p:spPr>
            <a:xfrm>
              <a:off x="492219" y="1363367"/>
              <a:ext cx="1630816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esidues 42-53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roAlanase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ptide) 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972516A-5359-B8F7-405B-8C1541A12509}"/>
                </a:ext>
              </a:extLst>
            </p:cNvPr>
            <p:cNvSpPr txBox="1"/>
            <p:nvPr/>
          </p:nvSpPr>
          <p:spPr>
            <a:xfrm>
              <a:off x="492219" y="3610820"/>
              <a:ext cx="1630816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esidues 71-85 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(Chymotrypsin peptide) 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43F6DAF-7897-6EE5-F2C0-0CCAE8A303C9}"/>
                </a:ext>
              </a:extLst>
            </p:cNvPr>
            <p:cNvSpPr txBox="1"/>
            <p:nvPr/>
          </p:nvSpPr>
          <p:spPr>
            <a:xfrm>
              <a:off x="492219" y="3350176"/>
              <a:ext cx="6944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b. PAF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4BA429E-6437-4012-140C-7784ED8E2947}"/>
                </a:ext>
              </a:extLst>
            </p:cNvPr>
            <p:cNvSpPr txBox="1"/>
            <p:nvPr/>
          </p:nvSpPr>
          <p:spPr>
            <a:xfrm>
              <a:off x="492219" y="5450411"/>
              <a:ext cx="10310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c. PAF/GN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33E2FF9-5431-4D11-C8DE-1D5726FD637D}"/>
                </a:ext>
              </a:extLst>
            </p:cNvPr>
            <p:cNvSpPr txBox="1"/>
            <p:nvPr/>
          </p:nvSpPr>
          <p:spPr>
            <a:xfrm>
              <a:off x="492220" y="5699554"/>
              <a:ext cx="1630816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esidues 42-53 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roAlanase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peptide) 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F69DEE8-91B9-9717-6375-F7A7B355D2C3}"/>
                </a:ext>
              </a:extLst>
            </p:cNvPr>
            <p:cNvSpPr txBox="1"/>
            <p:nvPr/>
          </p:nvSpPr>
          <p:spPr>
            <a:xfrm>
              <a:off x="492219" y="7779458"/>
              <a:ext cx="10390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d. PAF/GN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65CDC77-0BEA-222C-5175-D14096CE4ACF}"/>
                </a:ext>
              </a:extLst>
            </p:cNvPr>
            <p:cNvSpPr txBox="1"/>
            <p:nvPr/>
          </p:nvSpPr>
          <p:spPr>
            <a:xfrm>
              <a:off x="492219" y="7998260"/>
              <a:ext cx="168026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esidues 135-147 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(Chymotrypsin peptide) 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1E178F10-6F64-C06C-6B02-B3B964510B4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3796" y="7589765"/>
              <a:ext cx="2947919" cy="1966408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D11AF42D-5183-DD12-39C4-81B18D06BB3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673" y="5427216"/>
              <a:ext cx="2800164" cy="186784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653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60</Words>
  <Application>Microsoft Macintosh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TCHES, ELAINE C.</dc:creator>
  <cp:lastModifiedBy>FITCHES, ELAINE C.</cp:lastModifiedBy>
  <cp:revision>12</cp:revision>
  <dcterms:created xsi:type="dcterms:W3CDTF">2023-05-31T11:32:03Z</dcterms:created>
  <dcterms:modified xsi:type="dcterms:W3CDTF">2023-07-19T08:19:28Z</dcterms:modified>
</cp:coreProperties>
</file>